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72" y="5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4B4DA7-7D01-7E46-486D-50D9CD7C10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D0F91F-312E-B907-4AFD-A71E43BF0F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012EA8-E704-11AF-5BEF-D62ABF59C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7E9D70-DF9E-C81A-DED4-4BBE59790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5B99E2-BCEB-E95C-1E51-684EB757A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042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78E0AA-F747-B6D3-BFF6-5EE342498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BA8114-8411-0DA4-DA6B-8763453E13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39FB89-183E-4FFD-4E98-93C8EE68D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BADC82-6F02-1BF1-7A38-27788E0DF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CFA9DE-388E-73B7-A1A7-16FD099D8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451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012B82-6D29-42D9-89C6-CE4B03C6E7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B50E00-3004-5ABB-7E82-A2C273BEA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B9B07C-FD38-26BA-35B1-35E27E92B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6FFDD9-11DD-46BB-A198-5C927808A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9B1340-BA2C-9794-5278-E58948003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580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99A8FF-7CD5-45B6-6265-B951D09987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3C381D-5149-3643-225C-11ED5BF325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C5FAE8-8189-4D3B-D92E-469B57AD9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221042-BBEE-F9E2-5213-B30056482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3AB43E-6D27-07FA-9263-3F6B887AB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222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487FB5-3266-BAE7-1ADC-10614F114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076E9B-6DB8-5854-45AE-BA6E38DCC3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2ACF30-7CCC-9740-4C92-10F4F7EB2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CF1365-55C4-ABFA-F46F-99DE47951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613CE9-502B-52D2-E00B-82B21F5B49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709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736655-3F4D-C4D3-C168-1A16A35938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56FA9B-4091-8E64-C4D0-A754338A9A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C46434-D1B0-11E2-D2D1-91EDF2425B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60920B-10DE-8CF6-713A-962101E0C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1A67DE-5A20-B30C-45EE-2E3CBE7F4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82E08B-36CB-C3E7-791A-EB01CE0AF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1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8AB5D4-2A54-13B8-BED7-53FD7331FE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697186-E73A-8BB8-AC56-BCAB4D6524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1C0AE6-7981-35BB-EFE3-97642C26E7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7E38BF-FCCB-45A4-6B39-3FFEFDB776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8253921-399F-DBB5-24EF-76FE37701B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809CCC-27DD-85DD-D430-A6DAC1A7FD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734BFC-B5AD-5A15-01D9-2770E69A3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7FEE1B-B764-017E-8FC5-48C4ACCB3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02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D126E-3296-5D3F-BB7B-13363909E8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60355C-BBD0-82EC-AA53-F7D6D7BFA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BCDE8C-A7D5-8EDC-7EA5-1D2054B9A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37908D-03A0-4A6D-6C99-7B4E1F26E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85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9467D3-6CE1-43CF-DBCF-0305AC42C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AF8F2E-084A-C8E3-03FD-101C6883A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67E3E1-8F42-41ED-49F0-8314ED8DB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484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392B02-A050-C37C-7CE8-776CC4555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B8CAB8-7EB0-286A-5693-4DD41AD753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4C6102-9966-6AD4-5592-DEAE71653D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AADB65-70DE-A583-562F-9F6201D56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8C74DE-959F-BEEE-11BD-7B0B72241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485A52-D2D5-4910-B16F-856C20D6D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66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E9F535-F034-E465-D2B7-E5DADB4BC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BEDB946-1487-A272-84F0-8ECEDFA2E4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E482F7-2E2A-2EF6-76D7-1AA858A64F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3C67AC-5C7D-EFAE-F451-BD79822FB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617C47-7D5E-6E7F-4350-500D479B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4D5439-3BC0-4BC3-8F3E-8B3E35FE7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802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4BAD6DF-10D1-F6DD-7184-C384B16D6F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D0B72C-27E6-3F7A-4F2B-D6956A3173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470BBB-18D4-63A6-E655-9DC6D79C75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CEE8E72-FAE5-4835-91FE-CF627EB0F74D}" type="datetimeFigureOut">
              <a:rPr lang="en-US" smtClean="0"/>
              <a:t>4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6BFE65-7796-1193-4148-FA6E237242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DCB659-97B0-1650-E0C6-92B50BAC59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46D6937-5DC4-4549-A24C-28733F2C5A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767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2">
            <a:extLst>
              <a:ext uri="{FF2B5EF4-FFF2-40B4-BE49-F238E27FC236}">
                <a16:creationId xmlns:a16="http://schemas.microsoft.com/office/drawing/2014/main" id="{A156D5F7-6301-FA1F-772C-D7718C008AD1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5429250" cy="5429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6CCF18A-2FF1-C195-8E98-0C95D65620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36610"/>
            <a:ext cx="12192000" cy="45847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68130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E762554-AECD-E3C2-D94A-50D2FB58F3AD}"/>
              </a:ext>
            </a:extLst>
          </p:cNvPr>
          <p:cNvSpPr txBox="1"/>
          <p:nvPr/>
        </p:nvSpPr>
        <p:spPr>
          <a:xfrm>
            <a:off x="3048000" y="2753591"/>
            <a:ext cx="6096000" cy="13508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15000"/>
              </a:lnSpc>
              <a:spcAft>
                <a:spcPts val="800"/>
              </a:spcAft>
            </a:pPr>
            <a:r>
              <a:rPr lang="en-GB" sz="18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: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Graph of % change in 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ARylated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rotein (PAR) expression against % change in PSA from baseline (pre-treatment) for 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laparib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olaparib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lus </a:t>
            </a:r>
            <a:r>
              <a:rPr lang="en-GB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egarelix</a:t>
            </a:r>
            <a:r>
              <a:rPr lang="en-GB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ohorts.</a:t>
            </a:r>
            <a:endParaRPr lang="en-US" sz="1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0821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3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egmann, Bill</dc:creator>
  <cp:lastModifiedBy>Siegmann, Bill</cp:lastModifiedBy>
  <cp:revision>1</cp:revision>
  <dcterms:created xsi:type="dcterms:W3CDTF">2025-04-08T14:47:06Z</dcterms:created>
  <dcterms:modified xsi:type="dcterms:W3CDTF">2025-04-08T14:48:32Z</dcterms:modified>
</cp:coreProperties>
</file>